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3516E-8E24-7E32-F148-B845F2802A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E3CE1B-BBFB-4CD4-5BF1-8CFA295221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94898B-73F0-BEB4-FBF6-24B2F0B96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66B6B-E76C-68ED-03B1-250B67A31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72DDB2-7FAC-9AE0-7492-F64A5F980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7784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B624C1-76F3-35A8-6208-762BBF501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6D8E3B-7187-4213-6C32-E40D8BFD6C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441198-9F30-8CE4-C1CF-2E6AD5F5B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637AF9-B9E3-1ACF-2B0F-C7D852C83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4F0DC6-E75B-4083-6738-0F4943B09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786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73365C-EEEC-339E-9103-E9CF0DDE33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7D6B86-165F-55A7-4A95-9613AACE0F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199A04-F78A-DD66-CE63-306AD01D9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063B6A-7E63-8935-3DFA-A9A4DBA09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5040BD-6DE9-05E9-03CD-4804F45B4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051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682CC-D454-ED32-7610-3CF6434B6B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3BE9C4-CEC8-FFFF-345E-7AD93BB3F5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8CA58-6C1C-CC84-C445-EC57D4BDE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1D92A7-14EC-FBC3-F5A6-76EB96F27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2C9964-7E01-4CB9-B266-03836A6DC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1087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F44EE3-4F47-5499-A1B5-4D818F3C8F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2F79ED-9A17-2F0C-E7F9-52226B153A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6AAC58-3E5E-0381-E7AA-C19C8EA92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A37ADA-6D73-2CEB-0A5B-D4F0C48A0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F5142E-04A8-35FA-1113-2F283E865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365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1E6ED-6416-A6CB-093E-53C275F84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111A7B-9B40-E76C-268D-30AFE07D1E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44C919-B3C0-A069-F749-52D6E95F4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25980B-662C-3142-7522-CEF06676E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F31A5A-11C1-28A3-5CD6-1BF7A336B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4D2B0C-2CFC-20A2-69B9-8EA3E65DE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72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3BEE6-CB84-7BE7-B51A-8244611AC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BF5FE2-6118-C587-3FD0-01C9C30572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682957-FE05-06CB-693D-C0D6A7B676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33B359-D1FC-90FD-D8C3-C21C067D76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224319-E15B-5776-FE64-DC3C5A7C1C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0910779-19AB-47E6-83C6-6250A43B3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7A0B7F-2FEC-615F-1AB3-3261A7C77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49BED1-E90C-3748-8F25-5D4E18D86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9208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A319B-721E-95AF-0B74-92DA558FEF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DB9A67-8F52-7E2B-3766-79219FEF54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72936C-3F5F-77E5-B7D4-638384B02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C8CFD5-B7A0-ABBE-CE3E-9A5FDD69A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52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E6601D-5A8C-7DB4-763B-5CD204C8A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122855-C62F-FA95-78D6-1D8E317E1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AF8AF4-1214-AF5A-DAF5-4AC43B698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184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C0FD6-4C0A-13F0-5DA8-7C77A8171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6A292F-53EB-F239-132F-2459D353A2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92526D-BD99-5EC8-1558-CF3178B54D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D270BE-1EF0-C24B-12F5-65C4E5BE0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160F3-908B-2256-E6ED-CD52EB971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BC70A1-4E83-E145-1873-14565FB17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8119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AFD60-7D0E-5873-6C86-88DF91711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986B37-0790-0998-4A8C-475FCC8E2B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04A11A-C59C-B0D3-88A1-BB50164020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AE7B4F-9FCD-975E-C825-6B9BA518E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C1C4D2-E6A5-486A-AB69-8AACB831C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48DEF9-05DA-BF7F-691B-74A549822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4560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C10636-4335-C8EE-4737-E33FED196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A0161F-5467-FE8F-0678-FEEE4E2F47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68F333-934F-38F9-0FA2-899CE87B84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C353DF-E366-4B66-9CC3-9F362E7B9528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80BEC-1116-6A97-8A77-9C89BA3412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B1F3DF-05F9-8A4C-DF3C-94EA115E69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C4937A-30BF-4D7D-82FA-320A80C00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3093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50">
            <a:extLst>
              <a:ext uri="{FF2B5EF4-FFF2-40B4-BE49-F238E27FC236}">
                <a16:creationId xmlns:a16="http://schemas.microsoft.com/office/drawing/2014/main" id="{490106E0-0B6E-25F7-CA56-93A39F097E2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579"/>
          <a:stretch/>
        </p:blipFill>
        <p:spPr>
          <a:xfrm>
            <a:off x="1521517" y="160511"/>
            <a:ext cx="9148966" cy="65369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424DB8-E1E7-5F9B-E5D5-AB71C50F480A}"/>
              </a:ext>
            </a:extLst>
          </p:cNvPr>
          <p:cNvSpPr txBox="1"/>
          <p:nvPr/>
        </p:nvSpPr>
        <p:spPr>
          <a:xfrm>
            <a:off x="283029" y="6161314"/>
            <a:ext cx="7282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Online Supplementary figure 1; sequential diagrammatic reformulation  </a:t>
            </a:r>
          </a:p>
        </p:txBody>
      </p:sp>
    </p:spTree>
    <p:extLst>
      <p:ext uri="{BB962C8B-B14F-4D97-AF65-F5344CB8AC3E}">
        <p14:creationId xmlns:p14="http://schemas.microsoft.com/office/powerpoint/2010/main" val="15298496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3EC9334-73D7-392E-40A4-78344CF6027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456" t="2481" r="1747" b="2325"/>
          <a:stretch/>
        </p:blipFill>
        <p:spPr>
          <a:xfrm>
            <a:off x="1364512" y="170121"/>
            <a:ext cx="9462977" cy="652839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0A870B0-1E70-FCD2-39ED-08ABF4DEE36F}"/>
              </a:ext>
            </a:extLst>
          </p:cNvPr>
          <p:cNvSpPr txBox="1"/>
          <p:nvPr/>
        </p:nvSpPr>
        <p:spPr>
          <a:xfrm>
            <a:off x="250371" y="6041571"/>
            <a:ext cx="46243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Online Supplementary figure 2; change map 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2580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5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YCHLINSKI, Isobella (ROTHERHAM DONCASTER AND SOUTH HUMBER NHS FOUNDATION TRUST)</dc:creator>
  <cp:lastModifiedBy>KELLETT, Stephen (ROTHERHAM DONCASTER AND SOUTH HUMBER NHS FOUNDATION TRUST)</cp:lastModifiedBy>
  <cp:revision>3</cp:revision>
  <dcterms:created xsi:type="dcterms:W3CDTF">2024-12-05T15:55:36Z</dcterms:created>
  <dcterms:modified xsi:type="dcterms:W3CDTF">2025-07-22T11:18:14Z</dcterms:modified>
</cp:coreProperties>
</file>